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86" r:id="rId2"/>
  </p:sldIdLst>
  <p:sldSz cx="12192000" cy="6858000"/>
  <p:notesSz cx="6858000" cy="9144000"/>
  <p:defaultTextStyle>
    <a:defPPr>
      <a:defRPr lang="en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121" d="100"/>
          <a:sy n="121" d="100"/>
        </p:scale>
        <p:origin x="7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511926-BD81-A68E-5103-8AA9FB3905C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9AD93C6-7745-1EFC-16B2-73027200CDB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ED348A-FA79-2545-85DB-305CDD957A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4C8DE-4409-8D4E-812C-8A367667D46F}" type="datetimeFigureOut">
              <a:rPr lang="en-DE" smtClean="0"/>
              <a:t>15.07.25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4CE6DE-BF7F-D363-0CB7-32391E2A67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A7B28B-9174-E336-AFC5-E600438E79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CA1E9F-9059-E749-A131-ADEA0E51ABD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9009048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962E25-A792-66C6-0B02-0E997525F5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04196A9-8CA9-6942-83C5-66360353939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81E2D1-A653-7723-E88E-23B60101A8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4C8DE-4409-8D4E-812C-8A367667D46F}" type="datetimeFigureOut">
              <a:rPr lang="en-DE" smtClean="0"/>
              <a:t>15.07.25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A3AF6A-5751-F53C-D5DA-AB1D50C043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0D42FD-DC9B-BAC7-82E7-2BFCD7E456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CA1E9F-9059-E749-A131-ADEA0E51ABD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2661986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D024DE2-5597-ACC3-1FEC-FE6BE74FD9F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B5CFA22-B404-F748-C2A6-3A394276F8C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5B5D63-A2D9-4358-778B-60621D91F4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4C8DE-4409-8D4E-812C-8A367667D46F}" type="datetimeFigureOut">
              <a:rPr lang="en-DE" smtClean="0"/>
              <a:t>15.07.25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04A84D-7674-9037-3FA9-573BDFB94D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DB2816-9CB8-F47D-4EF1-777E8B2242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CA1E9F-9059-E749-A131-ADEA0E51ABD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6892636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220D89-E840-E8C4-5298-7E93CD3B09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C506DF0-DD96-9F1C-F91B-F50B158B367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1A4B64-B12C-232A-B793-B332054031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4C8DE-4409-8D4E-812C-8A367667D46F}" type="datetimeFigureOut">
              <a:rPr lang="en-DE" smtClean="0"/>
              <a:t>15.07.25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E28744-8EFE-A9C6-BF17-D251352CCA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041AB5-5DD9-F2DA-C37C-A298CADA03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CA1E9F-9059-E749-A131-ADEA0E51ABD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2437708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04A144-CB49-38A5-3FEE-CD42F0EB2B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7ED2F97-FFF1-F7D0-5160-C9794ECE69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98EA1A-FA6E-3A3E-F079-6C88532EC7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4C8DE-4409-8D4E-812C-8A367667D46F}" type="datetimeFigureOut">
              <a:rPr lang="en-DE" smtClean="0"/>
              <a:t>15.07.25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EED228-3F13-C976-71E9-CDE95760C0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DC62A14-6AE3-2255-6738-D925091276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CA1E9F-9059-E749-A131-ADEA0E51ABD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4969677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6084CA-1F55-3FAC-40FF-6C6A350EC2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1F4294E-5319-432B-78F8-0D6632178E9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CE94475-265D-15BC-C9C6-41D3D0BEC6B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317C62D-7B48-E56F-03D1-E274C51AF9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4C8DE-4409-8D4E-812C-8A367667D46F}" type="datetimeFigureOut">
              <a:rPr lang="en-DE" smtClean="0"/>
              <a:t>15.07.25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18B8197-FC27-C21C-C5B9-757C6BC540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C438753-0F1D-9C7F-6C87-F8D7080E67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CA1E9F-9059-E749-A131-ADEA0E51ABD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92203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2BF150-DEB6-C520-E910-2BF2FBA128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9A37A02-20D1-0136-EE6D-D36ABBA5A3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921C26B-A281-5984-5F5A-DEDC51F158B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32984AA-214D-9538-2714-423663DAD99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3B9C95C-A985-E3E5-261A-5EDB1C020C4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69818A8-6772-8246-765E-61BF645491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4C8DE-4409-8D4E-812C-8A367667D46F}" type="datetimeFigureOut">
              <a:rPr lang="en-DE" smtClean="0"/>
              <a:t>15.07.25</a:t>
            </a:fld>
            <a:endParaRPr lang="en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F73ED02-60E6-C296-B921-428BDDD3AC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059781B-42A8-92FF-A413-DC58EE7289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CA1E9F-9059-E749-A131-ADEA0E51ABD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38466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C59382-BA57-6BFE-9B5A-75CC4DDD4E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DBDF2C5-3596-AFB4-7DD1-16CB57D5EB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4C8DE-4409-8D4E-812C-8A367667D46F}" type="datetimeFigureOut">
              <a:rPr lang="en-DE" smtClean="0"/>
              <a:t>15.07.25</a:t>
            </a:fld>
            <a:endParaRPr lang="en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52024D4-7AF5-2414-57F0-01041D1FE1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34A4746-82D5-7533-8AE9-2ED74266FC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CA1E9F-9059-E749-A131-ADEA0E51ABD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9995429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664D40B-BAEA-FE20-3B73-4DD24A8B71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4C8DE-4409-8D4E-812C-8A367667D46F}" type="datetimeFigureOut">
              <a:rPr lang="en-DE" smtClean="0"/>
              <a:t>15.07.25</a:t>
            </a:fld>
            <a:endParaRPr lang="en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E582097-03B7-D6AC-157E-3D124D6D52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C6B1D00-569A-EAFB-D819-413869B1FA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CA1E9F-9059-E749-A131-ADEA0E51ABD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7692183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1305A5-D522-7D49-E294-2FEB7EEC55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62F8991-9A05-3761-5231-A7E369725F0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ECED230-A0DF-ABF8-68A8-C6F435ED0DD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CDD7525-875A-5507-76B1-3515168D13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4C8DE-4409-8D4E-812C-8A367667D46F}" type="datetimeFigureOut">
              <a:rPr lang="en-DE" smtClean="0"/>
              <a:t>15.07.25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23CCED8-47F6-D4B1-F1B7-98851E6CC1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CCB6978-4EF9-E6C7-79BF-4DF2A49EB1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CA1E9F-9059-E749-A131-ADEA0E51ABD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2127650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25C8A9-20F5-D07D-CDEB-6B6D4C0AE0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BCE5339-74B1-3D02-3172-03F57CD5A26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056A854-0B1D-CE4F-85C2-810F96C737E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51B69A2-C236-8A97-5FC5-ACF41E3B98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4C8DE-4409-8D4E-812C-8A367667D46F}" type="datetimeFigureOut">
              <a:rPr lang="en-DE" smtClean="0"/>
              <a:t>15.07.25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317140C-2C6F-0A94-D7A9-F4300A76FA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EE98892-5919-AF22-EA07-BD7D370FCA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CA1E9F-9059-E749-A131-ADEA0E51ABD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2593907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A387A53-8BBD-0BF2-19C0-3986B2410F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7D431DC-F7E2-F7A1-34F9-A0FE7BD8B7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1AA8ED-966A-57EF-97C2-70666370C06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684C8DE-4409-8D4E-812C-8A367667D46F}" type="datetimeFigureOut">
              <a:rPr lang="en-DE" smtClean="0"/>
              <a:t>15.07.25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D6D8B8-168E-CDA8-18D4-9188B7905D4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0D088E-FA9F-D966-C45B-FFC44729DE0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BCA1E9F-9059-E749-A131-ADEA0E51ABD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8529151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B5411AC7-FD37-4D88-9E8C-9ED9BEC5585B}"/>
              </a:ext>
            </a:extLst>
          </p:cNvPr>
          <p:cNvGrpSpPr/>
          <p:nvPr/>
        </p:nvGrpSpPr>
        <p:grpSpPr>
          <a:xfrm>
            <a:off x="3169240" y="941692"/>
            <a:ext cx="5270047" cy="3895624"/>
            <a:chOff x="526624" y="644480"/>
            <a:chExt cx="5270047" cy="3895624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FD72EA9B-2B1F-4663-8FC6-604978FF7D60}"/>
                </a:ext>
              </a:extLst>
            </p:cNvPr>
            <p:cNvGrpSpPr/>
            <p:nvPr/>
          </p:nvGrpSpPr>
          <p:grpSpPr>
            <a:xfrm>
              <a:off x="920366" y="644480"/>
              <a:ext cx="4876305" cy="3895624"/>
              <a:chOff x="770970" y="1771637"/>
              <a:chExt cx="4876305" cy="3895624"/>
            </a:xfrm>
          </p:grpSpPr>
          <p:pic>
            <p:nvPicPr>
              <p:cNvPr id="15" name="Picture 2">
                <a:extLst>
                  <a:ext uri="{FF2B5EF4-FFF2-40B4-BE49-F238E27FC236}">
                    <a16:creationId xmlns:a16="http://schemas.microsoft.com/office/drawing/2014/main" id="{9AD2D826-78B7-4962-976D-C19E384EA8C9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761" t="11577" r="12836" b="23591"/>
              <a:stretch/>
            </p:blipFill>
            <p:spPr bwMode="auto">
              <a:xfrm>
                <a:off x="779209" y="2395052"/>
                <a:ext cx="4382530" cy="2667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D40D36A1-CED1-4C07-A5BC-1C89E2D974FC}"/>
                  </a:ext>
                </a:extLst>
              </p:cNvPr>
              <p:cNvSpPr txBox="1"/>
              <p:nvPr/>
            </p:nvSpPr>
            <p:spPr>
              <a:xfrm>
                <a:off x="770970" y="2064025"/>
                <a:ext cx="4382531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00" b="1" dirty="0"/>
                  <a:t>  0.73nM    20nM                  48h       72h      96h        120h     140h       120h      140h</a:t>
                </a:r>
                <a:endParaRPr lang="en-AU" sz="1000" b="1" dirty="0"/>
              </a:p>
              <a:p>
                <a:endParaRPr lang="en-AU" dirty="0"/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CD7B0105-F703-4C72-9F03-428FA9B1F516}"/>
                  </a:ext>
                </a:extLst>
              </p:cNvPr>
              <p:cNvSpPr txBox="1"/>
              <p:nvPr/>
            </p:nvSpPr>
            <p:spPr>
              <a:xfrm>
                <a:off x="2609413" y="1771637"/>
                <a:ext cx="705642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300" b="1" dirty="0"/>
                  <a:t>TM38.4</a:t>
                </a:r>
                <a:endParaRPr lang="en-AU" sz="1300" b="1" dirty="0"/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F4F486D3-7581-4ED1-9DD8-6A2F4CB1AD41}"/>
                  </a:ext>
                </a:extLst>
              </p:cNvPr>
              <p:cNvSpPr txBox="1"/>
              <p:nvPr/>
            </p:nvSpPr>
            <p:spPr>
              <a:xfrm>
                <a:off x="4309642" y="1771993"/>
                <a:ext cx="712054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300" b="1" dirty="0"/>
                  <a:t>TM39.8</a:t>
                </a:r>
                <a:endParaRPr lang="en-AU" sz="1300" b="1" dirty="0"/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ECF05374-C1E4-4061-A462-250879C6957B}"/>
                  </a:ext>
                </a:extLst>
              </p:cNvPr>
              <p:cNvSpPr txBox="1"/>
              <p:nvPr/>
            </p:nvSpPr>
            <p:spPr>
              <a:xfrm>
                <a:off x="989812" y="1771637"/>
                <a:ext cx="772969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300" b="1" dirty="0"/>
                  <a:t>(+) HiBiT</a:t>
                </a:r>
                <a:endParaRPr lang="en-AU" sz="1300" b="1" dirty="0"/>
              </a:p>
            </p:txBody>
          </p:sp>
          <p:grpSp>
            <p:nvGrpSpPr>
              <p:cNvPr id="20" name="Group 19">
                <a:extLst>
                  <a:ext uri="{FF2B5EF4-FFF2-40B4-BE49-F238E27FC236}">
                    <a16:creationId xmlns:a16="http://schemas.microsoft.com/office/drawing/2014/main" id="{B59F6C3F-9EC1-44A6-937D-9DD01116CF85}"/>
                  </a:ext>
                </a:extLst>
              </p:cNvPr>
              <p:cNvGrpSpPr/>
              <p:nvPr/>
            </p:nvGrpSpPr>
            <p:grpSpPr>
              <a:xfrm>
                <a:off x="880228" y="5144041"/>
                <a:ext cx="4767047" cy="523220"/>
                <a:chOff x="498634" y="5244052"/>
                <a:chExt cx="4767047" cy="523220"/>
              </a:xfrm>
            </p:grpSpPr>
            <p:sp>
              <p:nvSpPr>
                <p:cNvPr id="21" name="TextBox 20">
                  <a:extLst>
                    <a:ext uri="{FF2B5EF4-FFF2-40B4-BE49-F238E27FC236}">
                      <a16:creationId xmlns:a16="http://schemas.microsoft.com/office/drawing/2014/main" id="{2AFE6D6A-1274-46D5-BE11-17A79B3DC1E7}"/>
                    </a:ext>
                  </a:extLst>
                </p:cNvPr>
                <p:cNvSpPr txBox="1"/>
                <p:nvPr/>
              </p:nvSpPr>
              <p:spPr>
                <a:xfrm>
                  <a:off x="498634" y="5244052"/>
                  <a:ext cx="4308388" cy="5232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1400" b="1" dirty="0"/>
                    <a:t>                              1.1     3.0      3.6      3.5     3.0     4.5     4.6</a:t>
                  </a:r>
                </a:p>
                <a:p>
                  <a:endParaRPr lang="en-AU" sz="1400" b="1" dirty="0"/>
                </a:p>
              </p:txBody>
            </p:sp>
            <p:sp>
              <p:nvSpPr>
                <p:cNvPr id="22" name="TextBox 21">
                  <a:extLst>
                    <a:ext uri="{FF2B5EF4-FFF2-40B4-BE49-F238E27FC236}">
                      <a16:creationId xmlns:a16="http://schemas.microsoft.com/office/drawing/2014/main" id="{8734EDBF-C180-4108-89B9-503CA2A1B1E8}"/>
                    </a:ext>
                  </a:extLst>
                </p:cNvPr>
                <p:cNvSpPr txBox="1"/>
                <p:nvPr/>
              </p:nvSpPr>
              <p:spPr>
                <a:xfrm>
                  <a:off x="4702706" y="5244052"/>
                  <a:ext cx="562975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1400" dirty="0"/>
                    <a:t>mg/L</a:t>
                  </a:r>
                  <a:endParaRPr lang="en-AU" sz="1400" dirty="0"/>
                </a:p>
              </p:txBody>
            </p:sp>
          </p:grpSp>
        </p:grpSp>
        <p:cxnSp>
          <p:nvCxnSpPr>
            <p:cNvPr id="6" name="Straight Connector 5">
              <a:extLst>
                <a:ext uri="{FF2B5EF4-FFF2-40B4-BE49-F238E27FC236}">
                  <a16:creationId xmlns:a16="http://schemas.microsoft.com/office/drawing/2014/main" id="{74343281-BBE5-4637-BDA2-D3970877A3D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81869" y="3266253"/>
              <a:ext cx="14795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Straight Connector 6">
              <a:extLst>
                <a:ext uri="{FF2B5EF4-FFF2-40B4-BE49-F238E27FC236}">
                  <a16:creationId xmlns:a16="http://schemas.microsoft.com/office/drawing/2014/main" id="{3BF7BFDE-ECE4-4DB1-A162-BE04C657951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81869" y="2928795"/>
              <a:ext cx="14795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Straight Connector 7">
              <a:extLst>
                <a:ext uri="{FF2B5EF4-FFF2-40B4-BE49-F238E27FC236}">
                  <a16:creationId xmlns:a16="http://schemas.microsoft.com/office/drawing/2014/main" id="{408E434F-E35E-468E-AE27-5CFF65D959C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81869" y="2732850"/>
              <a:ext cx="14795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id="{9E9152CF-6C5E-4136-9AB4-57E1E3D75AB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81869" y="2504250"/>
              <a:ext cx="14795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CA3C6660-0023-4BD7-8E86-5DA09D567995}"/>
                </a:ext>
              </a:extLst>
            </p:cNvPr>
            <p:cNvSpPr txBox="1"/>
            <p:nvPr/>
          </p:nvSpPr>
          <p:spPr>
            <a:xfrm>
              <a:off x="526624" y="2373081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DE" sz="1000" dirty="0"/>
                <a:t>40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41CE7409-B443-4F60-8907-457304159D02}"/>
                </a:ext>
              </a:extLst>
            </p:cNvPr>
            <p:cNvSpPr txBox="1"/>
            <p:nvPr/>
          </p:nvSpPr>
          <p:spPr>
            <a:xfrm>
              <a:off x="526624" y="2600115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DE" sz="1000" dirty="0"/>
                <a:t>35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84D7A976-C9A6-4577-AD87-A1F5823A7FB8}"/>
                </a:ext>
              </a:extLst>
            </p:cNvPr>
            <p:cNvSpPr txBox="1"/>
            <p:nvPr/>
          </p:nvSpPr>
          <p:spPr>
            <a:xfrm>
              <a:off x="526624" y="2819395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DE" sz="1000" dirty="0"/>
                <a:t>25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47950E24-26A3-43A6-ADA1-719831853AE9}"/>
                </a:ext>
              </a:extLst>
            </p:cNvPr>
            <p:cNvSpPr txBox="1"/>
            <p:nvPr/>
          </p:nvSpPr>
          <p:spPr>
            <a:xfrm>
              <a:off x="526624" y="3144403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DE" sz="1000" dirty="0"/>
                <a:t>15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19F23DC3-EA80-427E-AB1F-90F3CE7ADC08}"/>
                </a:ext>
              </a:extLst>
            </p:cNvPr>
            <p:cNvSpPr txBox="1"/>
            <p:nvPr/>
          </p:nvSpPr>
          <p:spPr>
            <a:xfrm>
              <a:off x="526625" y="1228517"/>
              <a:ext cx="3818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DE" sz="1000" dirty="0"/>
                <a:t>kDa</a:t>
              </a:r>
            </a:p>
          </p:txBody>
        </p:sp>
      </p:grpSp>
      <p:sp>
        <p:nvSpPr>
          <p:cNvPr id="23" name="TextBox 22">
            <a:extLst>
              <a:ext uri="{FF2B5EF4-FFF2-40B4-BE49-F238E27FC236}">
                <a16:creationId xmlns:a16="http://schemas.microsoft.com/office/drawing/2014/main" id="{6266EADD-299F-4601-AE9A-A3A3C5F53809}"/>
              </a:ext>
            </a:extLst>
          </p:cNvPr>
          <p:cNvSpPr txBox="1"/>
          <p:nvPr/>
        </p:nvSpPr>
        <p:spPr>
          <a:xfrm>
            <a:off x="4977778" y="157472"/>
            <a:ext cx="15897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galUA + glucose 5%</a:t>
            </a:r>
            <a:endParaRPr lang="en-AU" sz="14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FD8508AF-3553-49D0-B58B-E8151FA9BFC7}"/>
              </a:ext>
            </a:extLst>
          </p:cNvPr>
          <p:cNvSpPr txBox="1"/>
          <p:nvPr/>
        </p:nvSpPr>
        <p:spPr>
          <a:xfrm>
            <a:off x="6960085" y="457257"/>
            <a:ext cx="1471890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300" i="1" dirty="0"/>
              <a:t>PhttA::gaaA</a:t>
            </a:r>
            <a:r>
              <a:rPr lang="en-AU" sz="1300" b="1" i="1" baseline="-25000" dirty="0"/>
              <a:t> </a:t>
            </a:r>
            <a:r>
              <a:rPr lang="en-AU" sz="1300" b="1" i="1" dirty="0"/>
              <a:t> </a:t>
            </a:r>
            <a:br>
              <a:rPr lang="en-AU" sz="1300" b="1" i="1" dirty="0"/>
            </a:br>
            <a:r>
              <a:rPr lang="en-AU" sz="1300" i="1" dirty="0"/>
              <a:t>Prpl15::</a:t>
            </a:r>
            <a:r>
              <a:rPr lang="de-DE" sz="1300" i="1" dirty="0"/>
              <a:t>gatA</a:t>
            </a:r>
            <a:endParaRPr lang="en-AU" sz="1300" b="1" i="1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FC40A4A-C131-46E1-91FF-7604253E1D25}"/>
              </a:ext>
            </a:extLst>
          </p:cNvPr>
          <p:cNvSpPr txBox="1"/>
          <p:nvPr/>
        </p:nvSpPr>
        <p:spPr>
          <a:xfrm>
            <a:off x="5231077" y="597791"/>
            <a:ext cx="1471890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300" i="1" dirty="0"/>
              <a:t>PhttA::gaaA</a:t>
            </a:r>
            <a:r>
              <a:rPr lang="en-AU" sz="1300" b="1" i="1" baseline="-25000" dirty="0"/>
              <a:t> </a:t>
            </a:r>
            <a:r>
              <a:rPr lang="en-AU" sz="1300" b="1" i="1" dirty="0"/>
              <a:t> </a:t>
            </a:r>
            <a:br>
              <a:rPr lang="en-AU" sz="1300" b="1" i="1" dirty="0"/>
            </a:br>
            <a:endParaRPr lang="en-AU" sz="1300" b="1" i="1" dirty="0"/>
          </a:p>
        </p:txBody>
      </p:sp>
      <p:sp>
        <p:nvSpPr>
          <p:cNvPr id="26" name="Text Box 1">
            <a:extLst>
              <a:ext uri="{FF2B5EF4-FFF2-40B4-BE49-F238E27FC236}">
                <a16:creationId xmlns:a16="http://schemas.microsoft.com/office/drawing/2014/main" id="{37161D64-B60A-406C-BE99-0A7AD1A9A24E}"/>
              </a:ext>
            </a:extLst>
          </p:cNvPr>
          <p:cNvSpPr txBox="1"/>
          <p:nvPr/>
        </p:nvSpPr>
        <p:spPr>
          <a:xfrm>
            <a:off x="3556991" y="4698800"/>
            <a:ext cx="4638657" cy="2159200"/>
          </a:xfrm>
          <a:prstGeom prst="rect">
            <a:avLst/>
          </a:prstGeom>
          <a:noFill/>
          <a:ln>
            <a:noFill/>
          </a:ln>
          <a:effectLst/>
          <a:extLst>
            <a:ext uri="{C572A759-6A51-4108-AA02-DFA0A04FC94B}">
              <ma14:wrappingTextBoxFlag xmlns:lc="http://schemas.openxmlformats.org/drawingml/2006/lockedCanvas" xmlns:oel="http://schemas.microsoft.com/office/2019/extlst" xmlns:w16cex="http://schemas.microsoft.com/office/word/2018/wordml/cex" xmlns:w16="http://schemas.microsoft.com/office/word/2018/wordml" xmlns:w16sdtdh="http://schemas.microsoft.com/office/word/2020/wordml/sdtdatahash" xmlns:arto="http://schemas.microsoft.com/office/word/2006/arto" xmlns:ma14="http://schemas.microsoft.com/office/mac/drawingml/2011/main" xmlns:w="http://schemas.openxmlformats.org/wordprocessingml/2006/main" xmlns:w10="urn:schemas-microsoft-com:office:word" xmlns:v="urn:schemas-microsoft-com:vml" xmlns:o="urn:schemas-microsoft-com:office:office" xmlns:mv="urn:schemas-microsoft-com:mac:vml" xmlns:mo="http://schemas.microsoft.com/office/mac/office/2008/main" xmlns="" xmlns:wps="http://schemas.microsoft.com/office/word/2010/wordprocessingShape" xmlns:wne="http://schemas.microsoft.com/office/word/2006/wordml" xmlns:wpi="http://schemas.microsoft.com/office/word/2010/wordprocessingInk" xmlns:wpg="http://schemas.microsoft.com/office/word/2010/wordprocessingGroup" xmlns:w16se="http://schemas.microsoft.com/office/word/2015/wordml/symex" xmlns:w16cid="http://schemas.microsoft.com/office/word/2016/wordml/cid" xmlns:w15="http://schemas.microsoft.com/office/word/2012/wordml" xmlns:w14="http://schemas.microsoft.com/office/word/2010/wordml" xmlns:wp="http://schemas.openxmlformats.org/drawingml/2006/wordprocessingDrawing" xmlns:wp14="http://schemas.microsoft.com/office/word/2010/wordprocessingDrawing" xmlns:m="http://schemas.openxmlformats.org/officeDocument/2006/math" xmlns:am3d="http://schemas.microsoft.com/office/drawing/2017/model3d" xmlns:aink="http://schemas.microsoft.com/office/drawing/2016/ink" xmlns:mc="http://schemas.openxmlformats.org/markup-compatibility/2006" xmlns:cx8="http://schemas.microsoft.com/office/drawing/2016/5/14/chartex" xmlns:cx7="http://schemas.microsoft.com/office/drawing/2016/5/13/chartex" xmlns:cx6="http://schemas.microsoft.com/office/drawing/2016/5/12/chartex" xmlns:cx5="http://schemas.microsoft.com/office/drawing/2016/5/11/chartex" xmlns:cx4="http://schemas.microsoft.com/office/drawing/2016/5/10/chartex" xmlns:cx3="http://schemas.microsoft.com/office/drawing/2016/5/9/chartex" xmlns:cx2="http://schemas.microsoft.com/office/drawing/2015/10/21/chartex" xmlns:cx1="http://schemas.microsoft.com/office/drawing/2015/9/8/chartex" xmlns:cx="http://schemas.microsoft.com/office/drawing/2014/chartex" xmlns:wpc="http://schemas.microsoft.com/office/word/2010/wordprocessingCanvas"/>
            </a:ext>
          </a:extLst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/>
            <a:r>
              <a:rPr lang="en-DE" sz="1200" b="1" dirty="0">
                <a:latin typeface="Calibri" panose="020F0502020204030204" pitchFamily="34" charset="0"/>
                <a:cs typeface="Calibri" panose="020F0502020204030204" pitchFamily="34" charset="0"/>
              </a:rPr>
              <a:t>Additional File 8: </a:t>
            </a:r>
            <a:r>
              <a:rPr lang="en-AU" sz="1200" b="1" i="1" dirty="0">
                <a:effectLst/>
                <a:latin typeface="Calibri" panose="020F0502020204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A. niger</a:t>
            </a:r>
            <a:r>
              <a:rPr lang="en-AU" sz="1200" b="1" dirty="0">
                <a:effectLst/>
                <a:latin typeface="Calibri" panose="020F0502020204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 strains expressing collagen III under the </a:t>
            </a:r>
            <a:r>
              <a:rPr lang="en-AU" sz="1200" b="1" i="1" dirty="0">
                <a:effectLst/>
                <a:latin typeface="Calibri" panose="020F0502020204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tef1</a:t>
            </a:r>
            <a:r>
              <a:rPr lang="en-AU" sz="1200" b="1" dirty="0">
                <a:effectLst/>
                <a:latin typeface="Calibri" panose="020F0502020204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 promoter secrete the protein into the supernatant</a:t>
            </a:r>
            <a:br>
              <a:rPr lang="en-AU" sz="1200" b="1" dirty="0">
                <a:effectLst/>
                <a:latin typeface="Calibri" panose="020F0502020204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</a:br>
            <a:r>
              <a:rPr lang="en-DE" sz="1200" dirty="0"/>
              <a:t>HiBiT Blot of supernatant samples from TM38.4 and TM39.8. Supernatant samples collected from 25mL shake flasks of galUA medium with 50 g/L glucose, feeding with NH</a:t>
            </a:r>
            <a:r>
              <a:rPr lang="en-DE" sz="1200" baseline="-25000" dirty="0"/>
              <a:t>4</a:t>
            </a:r>
            <a:r>
              <a:rPr lang="en-DE" sz="1200" baseline="30000" dirty="0"/>
              <a:t>+</a:t>
            </a:r>
            <a:r>
              <a:rPr lang="en-DE" sz="1200" dirty="0"/>
              <a:t> to final concentration of 20</a:t>
            </a:r>
            <a:r>
              <a:rPr lang="de-DE" sz="1200" dirty="0"/>
              <a:t> </a:t>
            </a:r>
            <a:r>
              <a:rPr lang="en-DE" sz="1200" dirty="0"/>
              <a:t>mM every 24h. Supernatant proteins were seperated by SDS-PAGE</a:t>
            </a:r>
            <a:r>
              <a:rPr lang="de-DE" sz="1200" dirty="0"/>
              <a:t>, </a:t>
            </a:r>
            <a:r>
              <a:rPr lang="en-DE" sz="1200" dirty="0"/>
              <a:t>transferred to nitrocellulose</a:t>
            </a:r>
            <a:r>
              <a:rPr lang="de-DE" sz="1200" dirty="0"/>
              <a:t> and </a:t>
            </a:r>
            <a:r>
              <a:rPr lang="de-DE" sz="1200" dirty="0" err="1"/>
              <a:t>probed</a:t>
            </a:r>
            <a:r>
              <a:rPr lang="de-DE" sz="1200" dirty="0"/>
              <a:t> </a:t>
            </a:r>
            <a:r>
              <a:rPr lang="de-DE" sz="1200" dirty="0" err="1"/>
              <a:t>for</a:t>
            </a:r>
            <a:r>
              <a:rPr lang="de-DE" sz="1200" dirty="0"/>
              <a:t> </a:t>
            </a:r>
            <a:r>
              <a:rPr lang="de-DE" sz="1200" dirty="0" err="1"/>
              <a:t>HiBiT</a:t>
            </a:r>
            <a:r>
              <a:rPr lang="de-DE" sz="1200" dirty="0"/>
              <a:t> </a:t>
            </a:r>
            <a:r>
              <a:rPr lang="de-DE" sz="1200" dirty="0" err="1"/>
              <a:t>detection</a:t>
            </a:r>
            <a:r>
              <a:rPr lang="en-DE" sz="1200" dirty="0"/>
              <a:t>. A 37</a:t>
            </a:r>
            <a:r>
              <a:rPr lang="de-DE" sz="1200" dirty="0"/>
              <a:t> </a:t>
            </a:r>
            <a:r>
              <a:rPr lang="en-DE" sz="1200" dirty="0"/>
              <a:t>kDa Halo HiBiT positive control (+) was also used, and bands were analysed using imageJ for relative signal intensitiy</a:t>
            </a:r>
            <a:endParaRPr lang="en-DE" sz="1200" dirty="0">
              <a:effectLst/>
              <a:latin typeface="Calibri" panose="020F0502020204030204" pitchFamily="34" charset="0"/>
              <a:ea typeface="MS Mincho" panose="02020609040205080304" pitchFamily="49" charset="-128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071761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46</Words>
  <Application>Microsoft Macintosh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U-Pseudonym 1517372033116741</dc:creator>
  <cp:lastModifiedBy>TU-Pseudonym 1517372033116741</cp:lastModifiedBy>
  <cp:revision>1</cp:revision>
  <dcterms:created xsi:type="dcterms:W3CDTF">2025-07-15T18:50:49Z</dcterms:created>
  <dcterms:modified xsi:type="dcterms:W3CDTF">2025-07-15T18:53:49Z</dcterms:modified>
</cp:coreProperties>
</file>